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5E8954-002E-427C-A9E9-3B38F07CD94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268A78-1E95-4D98-A4FA-DE6F38443E6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A334CA-D011-456B-A6BD-BF3D2FF6A3C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716C3DE-A4FD-4D17-9BB8-D3A3B3EF16C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0441CA-15D1-43E5-A66B-2675835289F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9098ED-AFD8-4AC0-BFB9-C3B7F2ED8FD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EB8226-1546-4126-BD34-4B617C66396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15BDF7-4F69-4A38-B96A-7F0800132F5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1B40EF9-72FC-44AA-9B63-C0A7DB023F3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D07357-FE93-4E0A-BBDD-FAFA0C854CC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D555BAF-C76C-49D2-853C-DAB1B5D8B79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6C63ED-0856-4D57-BBEB-AB14AAEE2F3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FAA84FD-9A53-4155-9D7B-C4530BCCFB87}" type="slidenum">
              <a:rPr b="0" lang="it-IT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250920" y="188640"/>
            <a:ext cx="864216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List of the Ethics’ Committees </a:t>
            </a:r>
            <a:br>
              <a:rPr sz="2800"/>
            </a:b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and respective centers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2"/>
          <p:cNvSpPr>
            <a:spLocks noGrp="1"/>
          </p:cNvSpPr>
          <p:nvPr>
            <p:ph/>
          </p:nvPr>
        </p:nvSpPr>
        <p:spPr>
          <a:xfrm>
            <a:off x="457200" y="13320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 fontScale="84000"/>
          </a:bodyPr>
          <a:p>
            <a:pPr marL="288000" indent="-288000">
              <a:lnSpc>
                <a:spcPct val="80000"/>
              </a:lnSpc>
              <a:spcBef>
                <a:spcPts val="601"/>
              </a:spcBef>
              <a:spcAft>
                <a:spcPts val="601"/>
              </a:spcAft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400" spc="-1" strike="noStrike">
                <a:solidFill>
                  <a:srgbClr val="000000"/>
                </a:solidFill>
                <a:latin typeface="Arial"/>
              </a:rPr>
              <a:t>Comitato Etico Interaziendale Milano Area A.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lvl="1" marL="623880" indent="-239760">
              <a:lnSpc>
                <a:spcPct val="80000"/>
              </a:lnSpc>
              <a:spcBef>
                <a:spcPts val="601"/>
              </a:spcBef>
              <a:spcAft>
                <a:spcPts val="601"/>
              </a:spcAft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</a:t>
            </a:r>
            <a:r>
              <a:rPr b="0" lang="en-US" sz="1200" spc="-1" strike="noStrike" baseline="30000">
                <a:solidFill>
                  <a:srgbClr val="000000"/>
                </a:solidFill>
                <a:latin typeface="Arial"/>
              </a:rPr>
              <a:t>st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Division of Infectious Diseases, ASST Fatebenefratelli-Sacco, Milano, Italy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marL="288000" indent="-288000">
              <a:lnSpc>
                <a:spcPct val="80000"/>
              </a:lnSpc>
              <a:spcBef>
                <a:spcPts val="601"/>
              </a:spcBef>
              <a:spcAft>
                <a:spcPts val="601"/>
              </a:spcAft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400" spc="-1" strike="noStrike">
                <a:solidFill>
                  <a:srgbClr val="000000"/>
                </a:solidFill>
                <a:latin typeface="Arial"/>
              </a:rPr>
              <a:t>Comitato Etico delle Aziende Sanitarie dell’Umbria, Perugia.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lvl="1" marL="623880" indent="-239760">
              <a:lnSpc>
                <a:spcPct val="80000"/>
              </a:lnSpc>
              <a:spcBef>
                <a:spcPts val="601"/>
              </a:spcBef>
              <a:spcAft>
                <a:spcPts val="601"/>
              </a:spcAft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Infectious Diseases Clinic, Azienda Ospedaliero-Universitaria di Perugi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marL="288000" indent="-288000">
              <a:lnSpc>
                <a:spcPct val="80000"/>
              </a:lnSpc>
              <a:spcBef>
                <a:spcPts val="601"/>
              </a:spcBef>
              <a:spcAft>
                <a:spcPts val="601"/>
              </a:spcAft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400" spc="-1" strike="noStrike">
                <a:solidFill>
                  <a:srgbClr val="000000"/>
                </a:solidFill>
                <a:latin typeface="Arial"/>
              </a:rPr>
              <a:t>Comitato Etico Arnas Garibaldi, Catania.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lvl="1" marL="623880" indent="-239760">
              <a:lnSpc>
                <a:spcPct val="80000"/>
              </a:lnSpc>
              <a:spcBef>
                <a:spcPts val="601"/>
              </a:spcBef>
              <a:spcAft>
                <a:spcPts val="601"/>
              </a:spcAft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Arial"/>
              </a:rPr>
              <a:t>Infectious Diseases Unit, University of Catania, ARNAS (Azienda Ospedaliera di Rilievo Nazionale e di Alta Specializzazione) Garibaldi, Catani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marL="288000" indent="-288000">
              <a:lnSpc>
                <a:spcPct val="80000"/>
              </a:lnSpc>
              <a:spcBef>
                <a:spcPts val="601"/>
              </a:spcBef>
              <a:spcAft>
                <a:spcPts val="601"/>
              </a:spcAft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400" spc="-1" strike="noStrike">
                <a:solidFill>
                  <a:srgbClr val="000000"/>
                </a:solidFill>
                <a:latin typeface="Arial"/>
              </a:rPr>
              <a:t>Comitato Etico Regionale Regione Liguria.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lvl="1" marL="623880" indent="-239760">
              <a:lnSpc>
                <a:spcPct val="80000"/>
              </a:lnSpc>
              <a:spcBef>
                <a:spcPts val="601"/>
              </a:spcBef>
              <a:spcAft>
                <a:spcPts val="601"/>
              </a:spcAft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Arial"/>
              </a:rPr>
              <a:t>Infectious Diseases Clinic, ‘‘San Martino’’ Hospital, Genova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marL="288000" indent="-288000">
              <a:lnSpc>
                <a:spcPct val="80000"/>
              </a:lnSpc>
              <a:spcBef>
                <a:spcPts val="601"/>
              </a:spcBef>
              <a:spcAft>
                <a:spcPts val="601"/>
              </a:spcAft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400" spc="-1" strike="noStrike">
                <a:solidFill>
                  <a:srgbClr val="000000"/>
                </a:solidFill>
                <a:latin typeface="Arial"/>
              </a:rPr>
              <a:t>Comitato Etico Sperimentazione Clinica Azienda Ospedaliera-Universitaria Careggi, Firenze.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lvl="1" marL="623880" indent="-239760">
              <a:lnSpc>
                <a:spcPct val="80000"/>
              </a:lnSpc>
              <a:spcBef>
                <a:spcPts val="601"/>
              </a:spcBef>
              <a:spcAft>
                <a:spcPts val="601"/>
              </a:spcAft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Division of Infectious Diseases, ‘‘Careggi’’, Hospital, Firenze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marL="288000" indent="-288000">
              <a:lnSpc>
                <a:spcPct val="80000"/>
              </a:lnSpc>
              <a:spcBef>
                <a:spcPts val="601"/>
              </a:spcBef>
              <a:spcAft>
                <a:spcPts val="601"/>
              </a:spcAft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400" spc="-1" strike="noStrike">
                <a:solidFill>
                  <a:srgbClr val="000000"/>
                </a:solidFill>
                <a:latin typeface="Arial"/>
              </a:rPr>
              <a:t>Comitato Etico dell'Università Cattolica del Sacro Cuore - Policlinico Universitario Agostino Gemelli, Rom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lvl="1" marL="623880" indent="-239760">
              <a:lnSpc>
                <a:spcPct val="80000"/>
              </a:lnSpc>
              <a:spcBef>
                <a:spcPts val="601"/>
              </a:spcBef>
              <a:spcAft>
                <a:spcPts val="601"/>
              </a:spcAft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200" spc="-1" strike="noStrike" baseline="30000">
                <a:solidFill>
                  <a:srgbClr val="000000"/>
                </a:solidFill>
                <a:latin typeface="Arial"/>
              </a:rPr>
              <a:t>nd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Division of Infectious Diseases, ‘‘Policlinico Universitario Agostino Gemelli’’ Hospital, Rom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marL="288000" indent="-288000">
              <a:lnSpc>
                <a:spcPct val="80000"/>
              </a:lnSpc>
              <a:spcBef>
                <a:spcPts val="601"/>
              </a:spcBef>
              <a:spcAft>
                <a:spcPts val="601"/>
              </a:spcAft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400" spc="-1" strike="noStrike">
                <a:solidFill>
                  <a:srgbClr val="000000"/>
                </a:solidFill>
                <a:latin typeface="Arial"/>
              </a:rPr>
              <a:t>Comitato Etico IRCCS Policlinico San Matteo, Pavia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lvl="1" marL="623880" indent="-239760">
              <a:lnSpc>
                <a:spcPct val="80000"/>
              </a:lnSpc>
              <a:spcBef>
                <a:spcPts val="601"/>
              </a:spcBef>
              <a:spcAft>
                <a:spcPts val="601"/>
              </a:spcAft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200" spc="-1" strike="noStrike" baseline="30000">
                <a:solidFill>
                  <a:srgbClr val="000000"/>
                </a:solidFill>
                <a:latin typeface="Arial"/>
              </a:rPr>
              <a:t>nd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Division of Infectious Diseases, ‘‘Policlinico San Matteo’’ Hospital, Pavia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marL="288000" indent="-288000">
              <a:lnSpc>
                <a:spcPct val="80000"/>
              </a:lnSpc>
              <a:spcBef>
                <a:spcPts val="601"/>
              </a:spcBef>
              <a:spcAft>
                <a:spcPts val="601"/>
              </a:spcAft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400" spc="-1" strike="noStrike">
                <a:solidFill>
                  <a:srgbClr val="000000"/>
                </a:solidFill>
                <a:latin typeface="Arial"/>
              </a:rPr>
              <a:t>Comitato Etico della Asl to/2 di Torino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lvl="1" marL="623880" indent="-239760">
              <a:lnSpc>
                <a:spcPct val="80000"/>
              </a:lnSpc>
              <a:spcBef>
                <a:spcPts val="601"/>
              </a:spcBef>
              <a:spcAft>
                <a:spcPts val="601"/>
              </a:spcAft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Division of Infectious Diseases, ‘‘Amedeo di Savoia’’, Hospital, Torino </a:t>
            </a:r>
            <a:br>
              <a:rPr sz="1200"/>
            </a:br>
            <a:br>
              <a:rPr sz="1200"/>
            </a:br>
            <a:r>
              <a:rPr b="0" lang="it-IT" sz="12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05-12T15:34:40Z</dcterms:created>
  <dc:creator>rossodivita.alessand</dc:creator>
  <dc:description/>
  <dc:language>en-US</dc:language>
  <cp:lastModifiedBy>Capetti</cp:lastModifiedBy>
  <dcterms:modified xsi:type="dcterms:W3CDTF">2016-05-12T23:13:21Z</dcterms:modified>
  <cp:revision>2</cp:revision>
  <dc:subject/>
  <dc:title>List of the Ethics’ Committees  and respective centers</dc:title>
</cp:coreProperties>
</file>